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685800" y="1142640"/>
            <a:ext cx="5486400" cy="30862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E8F025F-9964-4DBF-AC60-6E08A06FCBC9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0" name="PlaceHolder 1"/>
          <p:cNvSpPr>
            <a:spLocks noGrp="1"/>
          </p:cNvSpPr>
          <p:nvPr>
            <p:ph type="sldImg"/>
          </p:nvPr>
        </p:nvSpPr>
        <p:spPr>
          <a:xfrm>
            <a:off x="685800" y="1143000"/>
            <a:ext cx="5486400" cy="3086280"/>
          </a:xfrm>
          <a:prstGeom prst="rect">
            <a:avLst/>
          </a:prstGeom>
          <a:ln w="0">
            <a:noFill/>
          </a:ln>
        </p:spPr>
      </p:sp>
      <p:sp>
        <p:nvSpPr>
          <p:cNvPr id="121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" name="スライド番号プレースホルダー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C3F82DF-7674-448E-B419-4C6ADE9A2D5F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A6C00E-0BBF-4B50-A5CB-F1A79D4E29B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EBC172-0BAA-4A35-8D75-45F88C0954B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478AFA-F205-4D24-833D-E06301C4794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807CAF-48D6-428A-A434-37D1D7EC6FE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C76632-DDDF-4DDA-93F9-522CA66EE76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4C6C99-2A9A-4D4F-9DCD-F5F7893858B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789132-1EAB-46E7-964A-DD0C6747C84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6EC685-C9F7-4003-969F-FE798F391B7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0C28C1-85BA-4DB5-8264-57FC0980D92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F99A91-9D06-4F9A-95F1-4A946DBCCC2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2F15C9-C80A-4EFD-9C1A-04813DB8D9E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73ADC8-9E63-49BF-8D6C-E55402BE7E9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7AC9E31-040D-466A-AB3E-575C34CE1E08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8" name=""/>
          <p:cNvGraphicFramePr/>
          <p:nvPr/>
        </p:nvGraphicFramePr>
        <p:xfrm>
          <a:off x="6967440" y="4637160"/>
          <a:ext cx="3843360" cy="1857240"/>
        </p:xfrm>
        <a:graphic>
          <a:graphicData uri="http://schemas.openxmlformats.org/drawingml/2006/table">
            <a:tbl>
              <a:tblPr/>
              <a:tblGrid>
                <a:gridCol w="3843360"/>
              </a:tblGrid>
              <a:tr h="371520"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OL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1520"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ase I.      </a:t>
                      </a:r>
                      <a:r>
                        <a:rPr b="0" lang="en-US" sz="1400" spc="-1" strike="noStrike">
                          <a:solidFill>
                            <a:srgbClr val="4472c4"/>
                          </a:solidFill>
                          <a:latin typeface="Arial"/>
                          <a:ea typeface="Arial"/>
                        </a:rPr>
                        <a:t>L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371160"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ase II.     </a:t>
                      </a:r>
                      <a:r>
                        <a:rPr b="0" lang="en-US" sz="1400" spc="-1" strike="noStrike">
                          <a:solidFill>
                            <a:srgbClr val="ed7d31"/>
                          </a:solidFill>
                          <a:latin typeface="Arial"/>
                          <a:ea typeface="Arial"/>
                        </a:rPr>
                        <a:t>MEPQ</a:t>
                      </a:r>
                      <a:r>
                        <a:rPr b="0" lang="ja-JP" sz="14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－</a:t>
                      </a:r>
                      <a:r>
                        <a:rPr b="0" lang="en-US" sz="1400" spc="-1" strike="noStrike">
                          <a:solidFill>
                            <a:srgbClr val="7030a0"/>
                          </a:solidFill>
                          <a:latin typeface="Arial"/>
                          <a:ea typeface="Arial"/>
                        </a:rPr>
                        <a:t>MSPT</a:t>
                      </a:r>
                      <a:r>
                        <a:rPr b="0" lang="ja-JP" sz="14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＋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371520"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ase III.    </a:t>
                      </a:r>
                      <a:r>
                        <a:rPr b="0" lang="en-US" sz="1400" spc="-1" strike="noStrike">
                          <a:solidFill>
                            <a:srgbClr val="7030a0"/>
                          </a:solidFill>
                          <a:latin typeface="Arial"/>
                          <a:ea typeface="Arial"/>
                        </a:rPr>
                        <a:t>MEPT</a:t>
                      </a:r>
                      <a:r>
                        <a:rPr b="0" lang="ja-JP" sz="14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－</a:t>
                      </a:r>
                      <a:r>
                        <a:rPr b="0" lang="en-US" sz="1400" spc="-1" strike="noStrike">
                          <a:solidFill>
                            <a:srgbClr val="ed7d31"/>
                          </a:solidFill>
                          <a:latin typeface="Arial"/>
                          <a:ea typeface="Arial"/>
                        </a:rPr>
                        <a:t>MSPQ</a:t>
                      </a:r>
                      <a:r>
                        <a:rPr b="0" lang="ja-JP" sz="14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＋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371520"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ase IV.    </a:t>
                      </a:r>
                      <a:r>
                        <a:rPr b="0" lang="en-US" sz="1400" spc="-1" strike="noStrike">
                          <a:solidFill>
                            <a:srgbClr val="4472c4"/>
                          </a:solidFill>
                          <a:latin typeface="Arial"/>
                          <a:ea typeface="Arial"/>
                        </a:rPr>
                        <a:t>Lq </a:t>
                      </a:r>
                      <a:r>
                        <a:rPr b="0" lang="ja-JP" sz="14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＋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gap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49" name="テキスト ボックス 56"/>
          <p:cNvSpPr/>
          <p:nvPr/>
        </p:nvSpPr>
        <p:spPr>
          <a:xfrm>
            <a:off x="874440" y="4059360"/>
            <a:ext cx="316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0" name="グループ化 4"/>
          <p:cNvGrpSpPr/>
          <p:nvPr/>
        </p:nvGrpSpPr>
        <p:grpSpPr>
          <a:xfrm>
            <a:off x="1852200" y="4086360"/>
            <a:ext cx="4712400" cy="2639880"/>
            <a:chOff x="1852200" y="4086360"/>
            <a:chExt cx="4712400" cy="2639880"/>
          </a:xfrm>
        </p:grpSpPr>
        <p:grpSp>
          <p:nvGrpSpPr>
            <p:cNvPr id="51" name="グループ化 4"/>
            <p:cNvGrpSpPr/>
            <p:nvPr/>
          </p:nvGrpSpPr>
          <p:grpSpPr>
            <a:xfrm>
              <a:off x="2357280" y="4627440"/>
              <a:ext cx="3725640" cy="2098800"/>
              <a:chOff x="2357280" y="4627440"/>
              <a:chExt cx="3725640" cy="2098800"/>
            </a:xfrm>
          </p:grpSpPr>
          <p:sp>
            <p:nvSpPr>
              <p:cNvPr id="52" name="直線コネクタ 47"/>
              <p:cNvSpPr/>
              <p:nvPr/>
            </p:nvSpPr>
            <p:spPr>
              <a:xfrm>
                <a:off x="5794200" y="4924080"/>
                <a:ext cx="0" cy="1802160"/>
              </a:xfrm>
              <a:prstGeom prst="line">
                <a:avLst/>
              </a:prstGeom>
              <a:ln w="6480">
                <a:solidFill>
                  <a:srgbClr val="5b9bd5"/>
                </a:solidFill>
                <a:prstDash val="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3" name="直線コネクタ 48"/>
              <p:cNvSpPr/>
              <p:nvPr/>
            </p:nvSpPr>
            <p:spPr>
              <a:xfrm>
                <a:off x="2553840" y="4916160"/>
                <a:ext cx="0" cy="1810080"/>
              </a:xfrm>
              <a:prstGeom prst="line">
                <a:avLst/>
              </a:prstGeom>
              <a:ln w="6480">
                <a:solidFill>
                  <a:srgbClr val="5b9bd5"/>
                </a:solidFill>
                <a:prstDash val="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54" name="グループ化 7"/>
              <p:cNvGrpSpPr/>
              <p:nvPr/>
            </p:nvGrpSpPr>
            <p:grpSpPr>
              <a:xfrm>
                <a:off x="2357280" y="4627440"/>
                <a:ext cx="3725640" cy="2098800"/>
                <a:chOff x="2357280" y="4627440"/>
                <a:chExt cx="3725640" cy="2098800"/>
              </a:xfrm>
            </p:grpSpPr>
            <p:sp>
              <p:nvSpPr>
                <p:cNvPr id="55" name="正方形/長方形 54"/>
                <p:cNvSpPr/>
                <p:nvPr/>
              </p:nvSpPr>
              <p:spPr>
                <a:xfrm>
                  <a:off x="2553840" y="4627440"/>
                  <a:ext cx="3240000" cy="288720"/>
                </a:xfrm>
                <a:prstGeom prst="rect">
                  <a:avLst/>
                </a:prstGeom>
                <a:solidFill>
                  <a:srgbClr val="deebf7"/>
                </a:solidFill>
                <a:ln w="3240">
                  <a:solidFill>
                    <a:srgbClr val="41719c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4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HLA cDNA database</a:t>
                  </a:r>
                  <a:endParaRPr b="0" lang="en-US" sz="1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6" name="正方形/長方形 59"/>
                <p:cNvSpPr/>
                <p:nvPr/>
              </p:nvSpPr>
              <p:spPr>
                <a:xfrm>
                  <a:off x="2357280" y="5101920"/>
                  <a:ext cx="3679920" cy="288720"/>
                </a:xfrm>
                <a:prstGeom prst="rect">
                  <a:avLst/>
                </a:prstGeom>
                <a:solidFill>
                  <a:srgbClr val="e2f0d9"/>
                </a:solidFill>
                <a:ln w="3240">
                  <a:solidFill>
                    <a:srgbClr val="70ad4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4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Candidates of haplotype</a:t>
                  </a:r>
                  <a:endParaRPr b="0" lang="en-US" sz="1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7" name="正方形/長方形 60"/>
                <p:cNvSpPr/>
                <p:nvPr/>
              </p:nvSpPr>
              <p:spPr>
                <a:xfrm>
                  <a:off x="2365200" y="5559480"/>
                  <a:ext cx="2378160" cy="288720"/>
                </a:xfrm>
                <a:prstGeom prst="rect">
                  <a:avLst/>
                </a:prstGeom>
                <a:solidFill>
                  <a:srgbClr val="e2f0d9"/>
                </a:solidFill>
                <a:ln w="3240">
                  <a:solidFill>
                    <a:srgbClr val="70ad4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4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Candidates of haplotype</a:t>
                  </a:r>
                  <a:endParaRPr b="0" lang="en-US" sz="1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8" name="正方形/長方形 61"/>
                <p:cNvSpPr/>
                <p:nvPr/>
              </p:nvSpPr>
              <p:spPr>
                <a:xfrm>
                  <a:off x="3704760" y="6010200"/>
                  <a:ext cx="2378160" cy="288720"/>
                </a:xfrm>
                <a:prstGeom prst="rect">
                  <a:avLst/>
                </a:prstGeom>
                <a:solidFill>
                  <a:srgbClr val="e2f0d9"/>
                </a:solidFill>
                <a:ln w="3240">
                  <a:solidFill>
                    <a:srgbClr val="70ad4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4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Candidates of haplotype</a:t>
                  </a:r>
                  <a:endParaRPr b="0" lang="en-US" sz="1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9" name="正方形/長方形 62"/>
                <p:cNvSpPr/>
                <p:nvPr/>
              </p:nvSpPr>
              <p:spPr>
                <a:xfrm>
                  <a:off x="3117600" y="6438960"/>
                  <a:ext cx="2378160" cy="287280"/>
                </a:xfrm>
                <a:prstGeom prst="rect">
                  <a:avLst/>
                </a:prstGeom>
                <a:solidFill>
                  <a:srgbClr val="e2f0d9"/>
                </a:solidFill>
                <a:ln w="3240">
                  <a:solidFill>
                    <a:srgbClr val="70ad4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4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Candidates of haplotype</a:t>
                  </a:r>
                  <a:endParaRPr b="0" lang="en-US" sz="1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</p:grpSp>
        <p:cxnSp>
          <p:nvCxnSpPr>
            <p:cNvPr id="60" name="直線矢印コネクタ 63"/>
            <p:cNvCxnSpPr/>
            <p:nvPr/>
          </p:nvCxnSpPr>
          <p:spPr>
            <a:xfrm>
              <a:off x="2552040" y="5005440"/>
              <a:ext cx="3250440" cy="3600"/>
            </a:xfrm>
            <a:prstGeom prst="straightConnector1">
              <a:avLst/>
            </a:prstGeom>
            <a:ln w="12600">
              <a:solidFill>
                <a:srgbClr val="ff0000"/>
              </a:solidFill>
              <a:miter/>
              <a:headEnd len="med" type="arrow" w="med"/>
              <a:tailEnd len="med" type="arrow" w="med"/>
            </a:ln>
          </p:spPr>
        </p:cxnSp>
        <p:cxnSp>
          <p:nvCxnSpPr>
            <p:cNvPr id="61" name="直線矢印コネクタ 64"/>
            <p:cNvCxnSpPr/>
            <p:nvPr/>
          </p:nvCxnSpPr>
          <p:spPr>
            <a:xfrm>
              <a:off x="2520360" y="5492520"/>
              <a:ext cx="2237400" cy="1080"/>
            </a:xfrm>
            <a:prstGeom prst="straightConnector1">
              <a:avLst/>
            </a:prstGeom>
            <a:ln w="12600">
              <a:solidFill>
                <a:srgbClr val="ff0000"/>
              </a:solidFill>
              <a:miter/>
              <a:headEnd len="med" type="arrow" w="med"/>
              <a:tailEnd len="med" type="arrow" w="med"/>
            </a:ln>
          </p:spPr>
        </p:cxnSp>
        <p:cxnSp>
          <p:nvCxnSpPr>
            <p:cNvPr id="62" name="直線矢印コネクタ 65"/>
            <p:cNvCxnSpPr/>
            <p:nvPr/>
          </p:nvCxnSpPr>
          <p:spPr>
            <a:xfrm>
              <a:off x="3704760" y="5942160"/>
              <a:ext cx="2097360" cy="3600"/>
            </a:xfrm>
            <a:prstGeom prst="straightConnector1">
              <a:avLst/>
            </a:prstGeom>
            <a:ln w="12600">
              <a:solidFill>
                <a:srgbClr val="ff0000"/>
              </a:solidFill>
              <a:miter/>
              <a:headEnd len="med" type="arrow" w="med"/>
              <a:tailEnd len="med" type="arrow" w="med"/>
            </a:ln>
          </p:spPr>
        </p:cxnSp>
        <p:cxnSp>
          <p:nvCxnSpPr>
            <p:cNvPr id="63" name="直線矢印コネクタ 66"/>
            <p:cNvCxnSpPr/>
            <p:nvPr/>
          </p:nvCxnSpPr>
          <p:spPr>
            <a:xfrm>
              <a:off x="3117600" y="6379920"/>
              <a:ext cx="2394720" cy="1080"/>
            </a:xfrm>
            <a:prstGeom prst="straightConnector1">
              <a:avLst/>
            </a:prstGeom>
            <a:ln w="12600">
              <a:solidFill>
                <a:srgbClr val="ff0000"/>
              </a:solidFill>
              <a:miter/>
              <a:headEnd len="med" type="arrow" w="med"/>
              <a:tailEnd len="med" type="arrow" w="med"/>
            </a:ln>
          </p:spPr>
        </p:cxnSp>
        <p:sp>
          <p:nvSpPr>
            <p:cNvPr id="64" name="正方形/長方形 4"/>
            <p:cNvSpPr/>
            <p:nvPr/>
          </p:nvSpPr>
          <p:spPr>
            <a:xfrm>
              <a:off x="2279160" y="4122720"/>
              <a:ext cx="674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7030a0"/>
                  </a:solidFill>
                  <a:latin typeface="Arial"/>
                  <a:ea typeface="Arial"/>
                </a:rPr>
                <a:t>MSPT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65" name="直線矢印コネクタ 69"/>
            <p:cNvCxnSpPr/>
            <p:nvPr/>
          </p:nvCxnSpPr>
          <p:spPr>
            <a:xfrm>
              <a:off x="2553840" y="4394160"/>
              <a:ext cx="1080" cy="265680"/>
            </a:xfrm>
            <a:prstGeom prst="straightConnector1">
              <a:avLst/>
            </a:prstGeom>
            <a:ln w="3240">
              <a:solidFill>
                <a:srgbClr val="ffc000"/>
              </a:solidFill>
              <a:miter/>
              <a:tailEnd len="med" type="arrow" w="med"/>
            </a:ln>
          </p:spPr>
        </p:cxnSp>
        <p:sp>
          <p:nvSpPr>
            <p:cNvPr id="66" name="正方形/長方形 70"/>
            <p:cNvSpPr/>
            <p:nvPr/>
          </p:nvSpPr>
          <p:spPr>
            <a:xfrm>
              <a:off x="5527800" y="4086360"/>
              <a:ext cx="674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7030a0"/>
                  </a:solidFill>
                  <a:latin typeface="Arial"/>
                  <a:ea typeface="Arial"/>
                </a:rPr>
                <a:t>MEPT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67" name="直線矢印コネクタ 71"/>
            <p:cNvCxnSpPr/>
            <p:nvPr/>
          </p:nvCxnSpPr>
          <p:spPr>
            <a:xfrm>
              <a:off x="5802120" y="4356000"/>
              <a:ext cx="1080" cy="265680"/>
            </a:xfrm>
            <a:prstGeom prst="straightConnector1">
              <a:avLst/>
            </a:prstGeom>
            <a:ln w="3240">
              <a:solidFill>
                <a:srgbClr val="ffc000"/>
              </a:solidFill>
              <a:miter/>
              <a:tailEnd len="med" type="arrow" w="med"/>
            </a:ln>
          </p:spPr>
        </p:cxnSp>
        <p:sp>
          <p:nvSpPr>
            <p:cNvPr id="68" name="正方形/長方形 72"/>
            <p:cNvSpPr/>
            <p:nvPr/>
          </p:nvSpPr>
          <p:spPr>
            <a:xfrm>
              <a:off x="1852200" y="4533840"/>
              <a:ext cx="704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c00000"/>
                  </a:solidFill>
                  <a:latin typeface="Arial"/>
                  <a:ea typeface="Arial"/>
                </a:rPr>
                <a:t>MSPQ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69" name="直線矢印コネクタ 73"/>
            <p:cNvCxnSpPr/>
            <p:nvPr/>
          </p:nvCxnSpPr>
          <p:spPr>
            <a:xfrm>
              <a:off x="2341080" y="4803840"/>
              <a:ext cx="1080" cy="265680"/>
            </a:xfrm>
            <a:prstGeom prst="straightConnector1">
              <a:avLst/>
            </a:prstGeom>
            <a:ln w="3240">
              <a:solidFill>
                <a:srgbClr val="c00000"/>
              </a:solidFill>
              <a:miter/>
              <a:tailEnd len="med" type="arrow" w="med"/>
            </a:ln>
          </p:spPr>
        </p:cxnSp>
        <p:sp>
          <p:nvSpPr>
            <p:cNvPr id="70" name="正方形/長方形 74"/>
            <p:cNvSpPr/>
            <p:nvPr/>
          </p:nvSpPr>
          <p:spPr>
            <a:xfrm>
              <a:off x="5859720" y="4494240"/>
              <a:ext cx="704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c00000"/>
                  </a:solidFill>
                  <a:latin typeface="Arial"/>
                  <a:ea typeface="Arial"/>
                </a:rPr>
                <a:t>MEPQ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71" name="直線矢印コネクタ 75"/>
            <p:cNvCxnSpPr/>
            <p:nvPr/>
          </p:nvCxnSpPr>
          <p:spPr>
            <a:xfrm>
              <a:off x="6060600" y="4836960"/>
              <a:ext cx="1080" cy="265680"/>
            </a:xfrm>
            <a:prstGeom prst="straightConnector1">
              <a:avLst/>
            </a:prstGeom>
            <a:ln w="3240">
              <a:solidFill>
                <a:srgbClr val="c00000"/>
              </a:solidFill>
              <a:miter/>
              <a:tailEnd len="med" type="arrow" w="med"/>
            </a:ln>
          </p:spPr>
        </p:cxnSp>
      </p:grpSp>
      <p:cxnSp>
        <p:nvCxnSpPr>
          <p:cNvPr id="72" name="直線矢印コネクタ 7"/>
          <p:cNvCxnSpPr/>
          <p:nvPr/>
        </p:nvCxnSpPr>
        <p:spPr>
          <a:xfrm>
            <a:off x="6192720" y="5203440"/>
            <a:ext cx="696240" cy="10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73" name="直線矢印コネクタ 72"/>
          <p:cNvCxnSpPr/>
          <p:nvPr/>
        </p:nvCxnSpPr>
        <p:spPr>
          <a:xfrm>
            <a:off x="6192720" y="5573520"/>
            <a:ext cx="696240" cy="10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74" name="直線矢印コネクタ 74"/>
          <p:cNvCxnSpPr/>
          <p:nvPr/>
        </p:nvCxnSpPr>
        <p:spPr>
          <a:xfrm>
            <a:off x="6192720" y="6005160"/>
            <a:ext cx="696240" cy="10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75" name="直線矢印コネクタ 76"/>
          <p:cNvCxnSpPr/>
          <p:nvPr/>
        </p:nvCxnSpPr>
        <p:spPr>
          <a:xfrm>
            <a:off x="6192720" y="6365520"/>
            <a:ext cx="696240" cy="10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arrow" w="med"/>
          </a:ln>
        </p:spPr>
      </p:cxnSp>
      <p:grpSp>
        <p:nvGrpSpPr>
          <p:cNvPr id="76" name="グループ化 2"/>
          <p:cNvGrpSpPr/>
          <p:nvPr/>
        </p:nvGrpSpPr>
        <p:grpSpPr>
          <a:xfrm>
            <a:off x="552600" y="561960"/>
            <a:ext cx="10104120" cy="3808080"/>
            <a:chOff x="552600" y="561960"/>
            <a:chExt cx="10104120" cy="3808080"/>
          </a:xfrm>
        </p:grpSpPr>
        <p:grpSp>
          <p:nvGrpSpPr>
            <p:cNvPr id="77" name="グループ化 1"/>
            <p:cNvGrpSpPr/>
            <p:nvPr/>
          </p:nvGrpSpPr>
          <p:grpSpPr>
            <a:xfrm>
              <a:off x="552600" y="561960"/>
              <a:ext cx="10104120" cy="3808080"/>
              <a:chOff x="552600" y="561960"/>
              <a:chExt cx="10104120" cy="3808080"/>
            </a:xfrm>
          </p:grpSpPr>
          <p:grpSp>
            <p:nvGrpSpPr>
              <p:cNvPr id="78" name="グループ化 2"/>
              <p:cNvGrpSpPr/>
              <p:nvPr/>
            </p:nvGrpSpPr>
            <p:grpSpPr>
              <a:xfrm>
                <a:off x="2063520" y="607680"/>
                <a:ext cx="8593200" cy="3762360"/>
                <a:chOff x="2063520" y="607680"/>
                <a:chExt cx="8593200" cy="3762360"/>
              </a:xfrm>
            </p:grpSpPr>
            <p:grpSp>
              <p:nvGrpSpPr>
                <p:cNvPr id="79" name="グループ化 85"/>
                <p:cNvGrpSpPr/>
                <p:nvPr/>
              </p:nvGrpSpPr>
              <p:grpSpPr>
                <a:xfrm>
                  <a:off x="2604600" y="2035800"/>
                  <a:ext cx="8052120" cy="2334240"/>
                  <a:chOff x="2604600" y="2035800"/>
                  <a:chExt cx="8052120" cy="2334240"/>
                </a:xfrm>
              </p:grpSpPr>
              <p:sp>
                <p:nvSpPr>
                  <p:cNvPr id="80" name="左大かっこ 42"/>
                  <p:cNvSpPr/>
                  <p:nvPr/>
                </p:nvSpPr>
                <p:spPr>
                  <a:xfrm rot="16200000">
                    <a:off x="6071760" y="-581400"/>
                    <a:ext cx="120600" cy="6480360"/>
                  </a:xfrm>
                  <a:custGeom>
                    <a:avLst/>
                    <a:gdLst>
                      <a:gd name="textAreaLeft" fmla="*/ 35280 w 120600"/>
                      <a:gd name="textAreaRight" fmla="*/ 120960 w 120600"/>
                      <a:gd name="textAreaTop" fmla="*/ 5040 h 6480360"/>
                      <a:gd name="textAreaBottom" fmla="*/ 6475320 h 6480360"/>
                    </a:gdLst>
                    <a:ahLst/>
                    <a:rect l="textAreaLeft" t="textAreaTop" r="textAreaRight" b="textAreaBottom"/>
                    <a:pathLst>
                      <a:path w="21600" h="21600">
                        <a:moveTo>
                          <a:pt x="21600" y="0"/>
                        </a:moveTo>
                        <a:cubicBezTo>
                          <a:pt x="10800" y="0"/>
                          <a:pt x="0" y="17"/>
                          <a:pt x="0" y="34"/>
                        </a:cubicBezTo>
                        <a:lnTo>
                          <a:pt x="0" y="21566"/>
                        </a:lnTo>
                        <a:cubicBezTo>
                          <a:pt x="0" y="21583"/>
                          <a:pt x="10800" y="21600"/>
                          <a:pt x="21600" y="21600"/>
                        </a:cubicBezTo>
                      </a:path>
                    </a:pathLst>
                  </a:custGeom>
                  <a:noFill/>
                  <a:ln w="6480">
                    <a:solidFill>
                      <a:srgbClr val="4472c4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1" name="テキスト ボックス 43"/>
                  <p:cNvSpPr/>
                  <p:nvPr/>
                </p:nvSpPr>
                <p:spPr>
                  <a:xfrm>
                    <a:off x="5895360" y="2680920"/>
                    <a:ext cx="378720" cy="3070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400" spc="-1" strike="noStrike">
                        <a:solidFill>
                          <a:srgbClr val="00b0f0"/>
                        </a:solidFill>
                        <a:latin typeface="Arial"/>
                        <a:ea typeface="Arial"/>
                      </a:rPr>
                      <a:t>Lq</a:t>
                    </a:r>
                    <a:endParaRPr b="0" lang="en-US" sz="14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2" name="テキスト ボックス 48"/>
                  <p:cNvSpPr/>
                  <p:nvPr/>
                </p:nvSpPr>
                <p:spPr>
                  <a:xfrm>
                    <a:off x="9108360" y="2670480"/>
                    <a:ext cx="378720" cy="3070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400" spc="-1" strike="noStrike">
                        <a:solidFill>
                          <a:srgbClr val="ed7d31"/>
                        </a:solidFill>
                        <a:latin typeface="Arial"/>
                        <a:ea typeface="Arial"/>
                      </a:rPr>
                      <a:t>51</a:t>
                    </a:r>
                    <a:endParaRPr b="0" lang="en-US" sz="14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grpSp>
                <p:nvGrpSpPr>
                  <p:cNvPr id="83" name="グループ化 82"/>
                  <p:cNvGrpSpPr/>
                  <p:nvPr/>
                </p:nvGrpSpPr>
                <p:grpSpPr>
                  <a:xfrm>
                    <a:off x="2604600" y="2035800"/>
                    <a:ext cx="8052120" cy="2334240"/>
                    <a:chOff x="2604600" y="2035800"/>
                    <a:chExt cx="8052120" cy="2334240"/>
                  </a:xfrm>
                </p:grpSpPr>
                <p:grpSp>
                  <p:nvGrpSpPr>
                    <p:cNvPr id="84" name="グループ化 45"/>
                    <p:cNvGrpSpPr/>
                    <p:nvPr/>
                  </p:nvGrpSpPr>
                  <p:grpSpPr>
                    <a:xfrm>
                      <a:off x="2604600" y="2692080"/>
                      <a:ext cx="1268280" cy="1136160"/>
                      <a:chOff x="2604600" y="2692080"/>
                      <a:chExt cx="1268280" cy="1136160"/>
                    </a:xfrm>
                  </p:grpSpPr>
                  <p:sp>
                    <p:nvSpPr>
                      <p:cNvPr id="85" name="テキスト ボックス 8"/>
                      <p:cNvSpPr/>
                      <p:nvPr/>
                    </p:nvSpPr>
                    <p:spPr>
                      <a:xfrm>
                        <a:off x="3434760" y="3143160"/>
                        <a:ext cx="438120" cy="307080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3240">
                        <a:solidFill>
                          <a:srgbClr val="0070c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wrap="none" lIns="90000" rIns="90000" tIns="46800" bIns="46800" anchor="t">
                        <a:spAutoFit/>
                      </a:bodyPr>
                      <a:p>
                        <a:pPr>
                          <a:lnSpc>
                            <a:spcPct val="100000"/>
                          </a:lnSpc>
                          <a:tabLst>
                            <a:tab algn="l" pos="0"/>
                            <a:tab algn="l" pos="914400"/>
                            <a:tab algn="l" pos="1828800"/>
                            <a:tab algn="l" pos="2743200"/>
                            <a:tab algn="l" pos="3657600"/>
                            <a:tab algn="l" pos="4572000"/>
                            <a:tab algn="l" pos="5486400"/>
                            <a:tab algn="l" pos="6400800"/>
                            <a:tab algn="l" pos="7315200"/>
                            <a:tab algn="l" pos="8229600"/>
                            <a:tab algn="l" pos="9144000"/>
                            <a:tab algn="l" pos="10058400"/>
                          </a:tabLst>
                        </a:pPr>
                        <a:r>
                          <a:rPr b="0" lang="en-US" sz="1400" spc="-1" strike="noStrike">
                            <a:solidFill>
                              <a:srgbClr val="0070c0"/>
                            </a:solidFill>
                            <a:latin typeface="Arial"/>
                            <a:ea typeface="Arial"/>
                          </a:rPr>
                          <a:t>QS</a:t>
                        </a:r>
                        <a:endPara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sp>
                    <p:nvSpPr>
                      <p:cNvPr id="86" name="テキスト ボックス 9"/>
                      <p:cNvSpPr/>
                      <p:nvPr/>
                    </p:nvSpPr>
                    <p:spPr>
                      <a:xfrm>
                        <a:off x="3064680" y="2692080"/>
                        <a:ext cx="607320" cy="27648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wrap="none" lIns="90000" rIns="90000" tIns="46800" bIns="46800" anchor="t">
                        <a:spAutoFit/>
                      </a:bodyPr>
                      <a:p>
                        <a:pPr>
                          <a:lnSpc>
                            <a:spcPct val="100000"/>
                          </a:lnSpc>
                          <a:tabLst>
                            <a:tab algn="l" pos="0"/>
                            <a:tab algn="l" pos="914400"/>
                            <a:tab algn="l" pos="1828800"/>
                            <a:tab algn="l" pos="2743200"/>
                            <a:tab algn="l" pos="3657600"/>
                            <a:tab algn="l" pos="4572000"/>
                            <a:tab algn="l" pos="5486400"/>
                            <a:tab algn="l" pos="6400800"/>
                            <a:tab algn="l" pos="7315200"/>
                            <a:tab algn="l" pos="8229600"/>
                            <a:tab algn="l" pos="9144000"/>
                            <a:tab algn="l" pos="10058400"/>
                          </a:tabLst>
                        </a:pPr>
                        <a:r>
                          <a:rPr b="0" lang="en-US" sz="1200" spc="-1" strike="noStrike">
                            <a:solidFill>
                              <a:srgbClr val="0070c0"/>
                            </a:solidFill>
                            <a:latin typeface="Arial"/>
                            <a:ea typeface="Arial"/>
                          </a:rPr>
                          <a:t>12345</a:t>
                        </a:r>
                        <a:endPara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sp>
                    <p:nvSpPr>
                      <p:cNvPr id="87" name="テキスト ボックス 12"/>
                      <p:cNvSpPr/>
                      <p:nvPr/>
                    </p:nvSpPr>
                    <p:spPr>
                      <a:xfrm>
                        <a:off x="2822040" y="2901960"/>
                        <a:ext cx="378720" cy="30708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wrap="none" lIns="90000" rIns="90000" tIns="46800" bIns="46800" anchor="t">
                        <a:spAutoFit/>
                      </a:bodyPr>
                      <a:p>
                        <a:pPr>
                          <a:lnSpc>
                            <a:spcPct val="100000"/>
                          </a:lnSpc>
                          <a:tabLst>
                            <a:tab algn="l" pos="0"/>
                            <a:tab algn="l" pos="914400"/>
                            <a:tab algn="l" pos="1828800"/>
                            <a:tab algn="l" pos="2743200"/>
                            <a:tab algn="l" pos="3657600"/>
                            <a:tab algn="l" pos="4572000"/>
                            <a:tab algn="l" pos="5486400"/>
                            <a:tab algn="l" pos="6400800"/>
                            <a:tab algn="l" pos="7315200"/>
                            <a:tab algn="l" pos="8229600"/>
                            <a:tab algn="l" pos="9144000"/>
                            <a:tab algn="l" pos="10058400"/>
                          </a:tabLst>
                        </a:pPr>
                        <a:r>
                          <a:rPr b="0" lang="en-US" sz="1400" spc="-1" strike="noStrike">
                            <a:solidFill>
                              <a:srgbClr val="ed7d31"/>
                            </a:solidFill>
                            <a:latin typeface="Arial"/>
                            <a:ea typeface="Arial"/>
                          </a:rPr>
                          <a:t>10</a:t>
                        </a:r>
                        <a:endPara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cxnSp>
                    <p:nvCxnSpPr>
                      <p:cNvPr id="88" name="直線矢印コネクタ 14"/>
                      <p:cNvCxnSpPr/>
                      <p:nvPr/>
                    </p:nvCxnSpPr>
                    <p:spPr>
                      <a:xfrm flipV="1">
                        <a:off x="3612960" y="2972520"/>
                        <a:ext cx="1080" cy="170640"/>
                      </a:xfrm>
                      <a:prstGeom prst="straightConnector1">
                        <a:avLst/>
                      </a:prstGeom>
                      <a:ln w="3240">
                        <a:solidFill>
                          <a:srgbClr val="0070c0"/>
                        </a:solidFill>
                        <a:miter/>
                        <a:tailEnd len="med" type="arrow" w="med"/>
                      </a:ln>
                    </p:spPr>
                  </p:cxnSp>
                  <p:sp>
                    <p:nvSpPr>
                      <p:cNvPr id="89" name="テキスト ボックス 15"/>
                      <p:cNvSpPr/>
                      <p:nvPr/>
                    </p:nvSpPr>
                    <p:spPr>
                      <a:xfrm>
                        <a:off x="2604600" y="3521160"/>
                        <a:ext cx="713160" cy="307080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3240">
                        <a:solidFill>
                          <a:srgbClr val="ed7d31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>
                        <a:spAutoFit/>
                      </a:bodyPr>
                      <a:p>
                        <a:pPr>
                          <a:lnSpc>
                            <a:spcPct val="100000"/>
                          </a:lnSpc>
                          <a:tabLst>
                            <a:tab algn="l" pos="0"/>
                            <a:tab algn="l" pos="914400"/>
                            <a:tab algn="l" pos="1828800"/>
                            <a:tab algn="l" pos="2743200"/>
                            <a:tab algn="l" pos="3657600"/>
                            <a:tab algn="l" pos="4572000"/>
                            <a:tab algn="l" pos="5486400"/>
                            <a:tab algn="l" pos="6400800"/>
                            <a:tab algn="l" pos="7315200"/>
                            <a:tab algn="l" pos="8229600"/>
                            <a:tab algn="l" pos="9144000"/>
                            <a:tab algn="l" pos="10058400"/>
                          </a:tabLst>
                        </a:pPr>
                        <a:r>
                          <a:rPr b="0" lang="en-US" sz="1400" spc="-1" strike="noStrike">
                            <a:solidFill>
                              <a:srgbClr val="ed7d31"/>
                            </a:solidFill>
                            <a:latin typeface="Arial"/>
                            <a:ea typeface="Arial"/>
                          </a:rPr>
                          <a:t>MSPQ </a:t>
                        </a:r>
                        <a:endPara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endParaRPr>
                      </a:p>
                    </p:txBody>
                  </p:sp>
                  <p:cxnSp>
                    <p:nvCxnSpPr>
                      <p:cNvPr id="90" name="直線矢印コネクタ 16"/>
                      <p:cNvCxnSpPr/>
                      <p:nvPr/>
                    </p:nvCxnSpPr>
                    <p:spPr>
                      <a:xfrm flipV="1">
                        <a:off x="2991600" y="3142800"/>
                        <a:ext cx="1080" cy="378720"/>
                      </a:xfrm>
                      <a:prstGeom prst="straightConnector1">
                        <a:avLst/>
                      </a:prstGeom>
                      <a:ln w="3240">
                        <a:solidFill>
                          <a:srgbClr val="ed7d31"/>
                        </a:solidFill>
                        <a:miter/>
                        <a:tailEnd len="med" type="arrow" w="med"/>
                      </a:ln>
                    </p:spPr>
                  </p:cxnSp>
                </p:grpSp>
                <p:sp>
                  <p:nvSpPr>
                    <p:cNvPr id="91" name="テキスト ボックス 49"/>
                    <p:cNvSpPr/>
                    <p:nvPr/>
                  </p:nvSpPr>
                  <p:spPr>
                    <a:xfrm>
                      <a:off x="6887880" y="3052440"/>
                      <a:ext cx="2700360" cy="520200"/>
                    </a:xfrm>
                    <a:prstGeom prst="rect">
                      <a:avLst/>
                    </a:prstGeom>
                    <a:solidFill>
                      <a:srgbClr val="ffffff"/>
                    </a:solidFill>
                    <a:ln w="3240">
                      <a:solidFill>
                        <a:srgbClr val="c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ed7d31"/>
                          </a:solidFill>
                          <a:latin typeface="Arial"/>
                          <a:ea typeface="Arial"/>
                        </a:rPr>
                        <a:t>MEPQ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ja-JP" sz="1400" spc="-1" strike="noStrike">
                          <a:solidFill>
                            <a:srgbClr val="000000"/>
                          </a:solidFill>
                          <a:latin typeface="Arial"/>
                          <a:ea typeface="ＭＳ 明朝"/>
                        </a:rPr>
                        <a:t>＝</a:t>
                      </a:r>
                      <a:r>
                        <a:rPr b="0" lang="ja-JP" sz="1400" spc="-1" strike="noStrike">
                          <a:solidFill>
                            <a:srgbClr val="ed7d31"/>
                          </a:solidFill>
                          <a:latin typeface="Arial"/>
                          <a:ea typeface="ＭＳ 明朝"/>
                        </a:rPr>
                        <a:t>　</a:t>
                      </a:r>
                      <a:r>
                        <a:rPr b="0" lang="en-US" sz="1400" spc="-1" strike="noStrike">
                          <a:solidFill>
                            <a:srgbClr val="ed7d31"/>
                          </a:solidFill>
                          <a:latin typeface="Arial"/>
                          <a:ea typeface="Arial"/>
                        </a:rPr>
                        <a:t>MSPQ</a:t>
                      </a:r>
                      <a:r>
                        <a:rPr b="0" lang="ja-JP" sz="1400" spc="-1" strike="noStrike">
                          <a:solidFill>
                            <a:srgbClr val="000000"/>
                          </a:solidFill>
                          <a:latin typeface="Arial"/>
                          <a:ea typeface="ＭＳ 明朝"/>
                        </a:rPr>
                        <a:t>＋</a:t>
                      </a:r>
                      <a:r>
                        <a:rPr b="0" lang="ja-JP" sz="1400" spc="-1" strike="noStrike">
                          <a:solidFill>
                            <a:srgbClr val="ed7d31"/>
                          </a:solidFill>
                          <a:latin typeface="Arial"/>
                          <a:ea typeface="ＭＳ 明朝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4bacc6"/>
                          </a:solidFill>
                          <a:latin typeface="Arial"/>
                          <a:ea typeface="Arial"/>
                        </a:rPr>
                        <a:t>Lq</a:t>
                      </a:r>
                      <a:r>
                        <a:rPr b="0" lang="ja-JP" sz="1400" spc="-1" strike="noStrike">
                          <a:solidFill>
                            <a:srgbClr val="000000"/>
                          </a:solidFill>
                          <a:latin typeface="Arial"/>
                          <a:ea typeface="ＭＳ 明朝"/>
                        </a:rPr>
                        <a:t>＋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gap </a:t>
                      </a:r>
                      <a:r>
                        <a:rPr b="0" lang="ja-JP" sz="1400" spc="-1" strike="noStrike">
                          <a:solidFill>
                            <a:srgbClr val="000000"/>
                          </a:solidFill>
                          <a:latin typeface="Arial"/>
                          <a:ea typeface="ＭＳ 明朝"/>
                        </a:rPr>
                        <a:t>－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  <p:cxnSp>
                  <p:nvCxnSpPr>
                    <p:cNvPr id="92" name="直線矢印コネクタ 50"/>
                    <p:cNvCxnSpPr/>
                    <p:nvPr/>
                  </p:nvCxnSpPr>
                  <p:spPr>
                    <a:xfrm flipV="1">
                      <a:off x="9297720" y="2912760"/>
                      <a:ext cx="1080" cy="133560"/>
                    </a:xfrm>
                    <a:prstGeom prst="straightConnector1">
                      <a:avLst/>
                    </a:prstGeom>
                    <a:ln w="3240">
                      <a:solidFill>
                        <a:srgbClr val="c00000"/>
                      </a:solidFill>
                      <a:miter/>
                      <a:tailEnd len="med" type="arrow" w="med"/>
                    </a:ln>
                  </p:spPr>
                </p:cxnSp>
                <p:sp>
                  <p:nvSpPr>
                    <p:cNvPr id="93" name="テキスト ボックス 52"/>
                    <p:cNvSpPr/>
                    <p:nvPr/>
                  </p:nvSpPr>
                  <p:spPr>
                    <a:xfrm>
                      <a:off x="9096480" y="3636720"/>
                      <a:ext cx="1560240" cy="733320"/>
                    </a:xfrm>
                    <a:prstGeom prst="rect">
                      <a:avLst/>
                    </a:prstGeom>
                    <a:solidFill>
                      <a:srgbClr val="ffffff"/>
                    </a:solidFill>
                    <a:ln w="3240">
                      <a:solidFill>
                        <a:srgbClr val="7030a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7030a0"/>
                          </a:solidFill>
                          <a:latin typeface="Arial"/>
                          <a:ea typeface="Arial"/>
                        </a:rPr>
                        <a:t>MEP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= </a:t>
                      </a:r>
                      <a:r>
                        <a:rPr b="0" lang="en-US" sz="1400" spc="-1" strike="noStrike">
                          <a:solidFill>
                            <a:srgbClr val="7030a0"/>
                          </a:solidFill>
                          <a:latin typeface="Arial"/>
                          <a:ea typeface="Arial"/>
                        </a:rPr>
                        <a:t>MSPT</a:t>
                      </a:r>
                      <a:r>
                        <a:rPr b="0" lang="ja-JP" sz="1400" spc="-1" strike="noStrike">
                          <a:solidFill>
                            <a:srgbClr val="000000"/>
                          </a:solidFill>
                          <a:latin typeface="Arial"/>
                          <a:ea typeface="ＭＳ 明朝"/>
                        </a:rPr>
                        <a:t>＋</a:t>
                      </a:r>
                      <a:r>
                        <a:rPr b="0" lang="ja-JP" sz="1400" spc="-1" strike="noStrike">
                          <a:solidFill>
                            <a:srgbClr val="ed7d31"/>
                          </a:solidFill>
                          <a:latin typeface="Arial"/>
                          <a:ea typeface="ＭＳ 明朝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4bacc6"/>
                          </a:solidFill>
                          <a:latin typeface="Arial"/>
                          <a:ea typeface="Arial"/>
                        </a:rPr>
                        <a:t>Lt</a:t>
                      </a:r>
                      <a:r>
                        <a:rPr b="0" lang="ja-JP" sz="1400" spc="-1" strike="noStrike">
                          <a:solidFill>
                            <a:srgbClr val="000000"/>
                          </a:solidFill>
                          <a:latin typeface="Arial"/>
                          <a:ea typeface="ＭＳ 明朝"/>
                        </a:rPr>
                        <a:t>－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  <p:cxnSp>
                  <p:nvCxnSpPr>
                    <p:cNvPr id="94" name="直線矢印コネクタ 53"/>
                    <p:cNvCxnSpPr>
                      <a:stCxn id="93" idx="0"/>
                    </p:cNvCxnSpPr>
                    <p:nvPr/>
                  </p:nvCxnSpPr>
                  <p:spPr>
                    <a:xfrm flipH="1" flipV="1">
                      <a:off x="9861120" y="2035800"/>
                      <a:ext cx="15840" cy="1601280"/>
                    </a:xfrm>
                    <a:prstGeom prst="straightConnector1">
                      <a:avLst/>
                    </a:prstGeom>
                    <a:ln w="3240">
                      <a:solidFill>
                        <a:srgbClr val="7030a0"/>
                      </a:solidFill>
                      <a:miter/>
                      <a:tailEnd len="med" type="arrow" w="med"/>
                    </a:ln>
                  </p:spPr>
                </p:cxnSp>
              </p:grpSp>
            </p:grpSp>
            <p:grpSp>
              <p:nvGrpSpPr>
                <p:cNvPr id="95" name="グループ化 1"/>
                <p:cNvGrpSpPr/>
                <p:nvPr/>
              </p:nvGrpSpPr>
              <p:grpSpPr>
                <a:xfrm>
                  <a:off x="2063520" y="607680"/>
                  <a:ext cx="8093880" cy="2016000"/>
                  <a:chOff x="2063520" y="607680"/>
                  <a:chExt cx="8093880" cy="2016000"/>
                </a:xfrm>
              </p:grpSpPr>
              <p:grpSp>
                <p:nvGrpSpPr>
                  <p:cNvPr id="96" name="グループ化 86"/>
                  <p:cNvGrpSpPr/>
                  <p:nvPr/>
                </p:nvGrpSpPr>
                <p:grpSpPr>
                  <a:xfrm>
                    <a:off x="2063520" y="607680"/>
                    <a:ext cx="8001000" cy="1148040"/>
                    <a:chOff x="2063520" y="607680"/>
                    <a:chExt cx="8001000" cy="1148040"/>
                  </a:xfrm>
                </p:grpSpPr>
                <p:grpSp>
                  <p:nvGrpSpPr>
                    <p:cNvPr id="97" name="グループ化 44"/>
                    <p:cNvGrpSpPr/>
                    <p:nvPr/>
                  </p:nvGrpSpPr>
                  <p:grpSpPr>
                    <a:xfrm>
                      <a:off x="2063520" y="607680"/>
                      <a:ext cx="2570400" cy="1081440"/>
                      <a:chOff x="2063520" y="607680"/>
                      <a:chExt cx="2570400" cy="1081440"/>
                    </a:xfrm>
                  </p:grpSpPr>
                  <p:grpSp>
                    <p:nvGrpSpPr>
                      <p:cNvPr id="98" name="グループ化 38"/>
                      <p:cNvGrpSpPr/>
                      <p:nvPr/>
                    </p:nvGrpSpPr>
                    <p:grpSpPr>
                      <a:xfrm>
                        <a:off x="3143520" y="897840"/>
                        <a:ext cx="803880" cy="791280"/>
                        <a:chOff x="3143520" y="897840"/>
                        <a:chExt cx="803880" cy="791280"/>
                      </a:xfrm>
                    </p:grpSpPr>
                    <p:sp>
                      <p:nvSpPr>
                        <p:cNvPr id="99" name="テキスト ボックス 18"/>
                        <p:cNvSpPr/>
                        <p:nvPr/>
                      </p:nvSpPr>
                      <p:spPr>
                        <a:xfrm>
                          <a:off x="3143520" y="1412640"/>
                          <a:ext cx="719640" cy="276480"/>
                        </a:xfrm>
                        <a:prstGeom prst="rect">
                          <a:avLst/>
                        </a:prstGeom>
                        <a:noFill/>
                        <a:ln w="0">
                          <a:noFill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46800" bIns="46800" anchor="t">
                          <a:spAutoFit/>
                        </a:bodyPr>
                        <a:p>
                          <a:pPr>
                            <a:lnSpc>
                              <a:spcPct val="100000"/>
                            </a:lnSpc>
                            <a:tabLst>
                              <a:tab algn="l" pos="0"/>
                              <a:tab algn="l" pos="914400"/>
                              <a:tab algn="l" pos="1828800"/>
                              <a:tab algn="l" pos="2743200"/>
                              <a:tab algn="l" pos="3657600"/>
                              <a:tab algn="l" pos="4572000"/>
                              <a:tab algn="l" pos="5486400"/>
                              <a:tab algn="l" pos="6400800"/>
                              <a:tab algn="l" pos="7315200"/>
                              <a:tab algn="l" pos="8229600"/>
                              <a:tab algn="l" pos="9144000"/>
                              <a:tab algn="l" pos="10058400"/>
                            </a:tabLst>
                          </a:pPr>
                          <a:r>
                            <a:rPr b="0" lang="en-US" sz="1200" spc="-1" strike="noStrike">
                              <a:solidFill>
                                <a:srgbClr val="00b050"/>
                              </a:solidFill>
                              <a:latin typeface="Arial"/>
                              <a:ea typeface="Arial"/>
                            </a:rPr>
                            <a:t>123</a:t>
                          </a:r>
                          <a:endParaRPr b="0" lang="en-US" sz="1200" spc="-1" strike="noStrike">
                            <a:solidFill>
                              <a:srgbClr val="000000"/>
                            </a:solidFill>
                            <a:latin typeface="Calibri"/>
                          </a:endParaRPr>
                        </a:p>
                      </p:txBody>
                    </p:sp>
                    <p:sp>
                      <p:nvSpPr>
                        <p:cNvPr id="100" name="テキスト ボックス 19"/>
                        <p:cNvSpPr/>
                        <p:nvPr/>
                      </p:nvSpPr>
                      <p:spPr>
                        <a:xfrm>
                          <a:off x="3445200" y="948600"/>
                          <a:ext cx="502200" cy="307080"/>
                        </a:xfrm>
                        <a:prstGeom prst="rect">
                          <a:avLst/>
                        </a:prstGeom>
                        <a:solidFill>
                          <a:srgbClr val="ffffff"/>
                        </a:solidFill>
                        <a:ln w="3240">
                          <a:solidFill>
                            <a:srgbClr val="00b050"/>
                          </a:solidFill>
                          <a:miter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46800" bIns="46800" anchor="t">
                          <a:spAutoFit/>
                        </a:bodyPr>
                        <a:p>
                          <a:pPr algn="ctr">
                            <a:lnSpc>
                              <a:spcPct val="100000"/>
                            </a:lnSpc>
                            <a:tabLst>
                              <a:tab algn="l" pos="0"/>
                              <a:tab algn="l" pos="914400"/>
                              <a:tab algn="l" pos="1828800"/>
                              <a:tab algn="l" pos="2743200"/>
                              <a:tab algn="l" pos="3657600"/>
                              <a:tab algn="l" pos="4572000"/>
                              <a:tab algn="l" pos="5486400"/>
                              <a:tab algn="l" pos="6400800"/>
                              <a:tab algn="l" pos="7315200"/>
                              <a:tab algn="l" pos="8229600"/>
                              <a:tab algn="l" pos="9144000"/>
                              <a:tab algn="l" pos="10058400"/>
                            </a:tabLst>
                          </a:pPr>
                          <a:r>
                            <a:rPr b="0" lang="en-US" sz="1400" spc="-1" strike="noStrike">
                              <a:solidFill>
                                <a:srgbClr val="00b050"/>
                              </a:solidFill>
                              <a:latin typeface="Arial"/>
                              <a:ea typeface="Arial"/>
                            </a:rPr>
                            <a:t>TS</a:t>
                          </a:r>
                          <a:endParaRPr b="0" lang="en-US" sz="1400" spc="-1" strike="noStrike">
                            <a:solidFill>
                              <a:srgbClr val="000000"/>
                            </a:solidFill>
                            <a:latin typeface="Calibri"/>
                          </a:endParaRPr>
                        </a:p>
                      </p:txBody>
                    </p:sp>
                    <p:cxnSp>
                      <p:nvCxnSpPr>
                        <p:cNvPr id="101" name="直線矢印コネクタ 20"/>
                        <p:cNvCxnSpPr/>
                        <p:nvPr/>
                      </p:nvCxnSpPr>
                      <p:spPr>
                        <a:xfrm>
                          <a:off x="3560760" y="1259640"/>
                          <a:ext cx="1080" cy="184680"/>
                        </a:xfrm>
                        <a:prstGeom prst="straightConnector1">
                          <a:avLst/>
                        </a:prstGeom>
                        <a:ln w="3240">
                          <a:solidFill>
                            <a:srgbClr val="00b050"/>
                          </a:solidFill>
                          <a:miter/>
                          <a:tailEnd len="med" type="arrow" w="med"/>
                        </a:ln>
                      </p:spPr>
                    </p:cxnSp>
                    <p:cxnSp>
                      <p:nvCxnSpPr>
                        <p:cNvPr id="102" name="直線矢印コネクタ 29"/>
                        <p:cNvCxnSpPr/>
                        <p:nvPr/>
                      </p:nvCxnSpPr>
                      <p:spPr>
                        <a:xfrm>
                          <a:off x="3243960" y="897840"/>
                          <a:ext cx="1080" cy="531360"/>
                        </a:xfrm>
                        <a:prstGeom prst="straightConnector1">
                          <a:avLst/>
                        </a:prstGeom>
                        <a:ln w="3240">
                          <a:solidFill>
                            <a:srgbClr val="ffc000"/>
                          </a:solidFill>
                          <a:miter/>
                          <a:tailEnd len="med" type="arrow" w="med"/>
                        </a:ln>
                      </p:spPr>
                    </p:cxnSp>
                  </p:grpSp>
                  <p:grpSp>
                    <p:nvGrpSpPr>
                      <p:cNvPr id="103" name="グループ化 37"/>
                      <p:cNvGrpSpPr/>
                      <p:nvPr/>
                    </p:nvGrpSpPr>
                    <p:grpSpPr>
                      <a:xfrm>
                        <a:off x="2063520" y="607680"/>
                        <a:ext cx="2570400" cy="520200"/>
                        <a:chOff x="2063520" y="607680"/>
                        <a:chExt cx="2570400" cy="520200"/>
                      </a:xfrm>
                    </p:grpSpPr>
                    <p:sp>
                      <p:nvSpPr>
                        <p:cNvPr id="104" name="正方形/長方形 36"/>
                        <p:cNvSpPr/>
                        <p:nvPr/>
                      </p:nvSpPr>
                      <p:spPr>
                        <a:xfrm>
                          <a:off x="2063520" y="607680"/>
                          <a:ext cx="2462400" cy="289080"/>
                        </a:xfrm>
                        <a:prstGeom prst="rect">
                          <a:avLst/>
                        </a:prstGeom>
                        <a:solidFill>
                          <a:srgbClr val="ffffff"/>
                        </a:solidFill>
                        <a:ln w="12600">
                          <a:solidFill>
                            <a:srgbClr val="ffc000"/>
                          </a:solidFill>
                          <a:miter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46800" bIns="46800" anchor="ctr">
                          <a:noAutofit/>
                        </a:bodyPr>
                        <a:p>
                          <a:pPr algn="ctr">
                            <a:tabLst>
                              <a:tab algn="l" pos="0"/>
                              <a:tab algn="l" pos="914400"/>
                              <a:tab algn="l" pos="1828800"/>
                              <a:tab algn="l" pos="2743200"/>
                              <a:tab algn="l" pos="3657600"/>
                              <a:tab algn="l" pos="4572000"/>
                              <a:tab algn="l" pos="5486400"/>
                              <a:tab algn="l" pos="6400800"/>
                              <a:tab algn="l" pos="7315200"/>
                              <a:tab algn="l" pos="8229600"/>
                              <a:tab algn="l" pos="9144000"/>
                              <a:tab algn="l" pos="10058400"/>
                            </a:tabLst>
                          </a:pPr>
                          <a:endParaRPr b="0" lang="en-US" sz="2400" spc="-1" strike="noStrike">
                            <a:solidFill>
                              <a:srgbClr val="000000"/>
                            </a:solidFill>
                            <a:latin typeface="Calibri"/>
                          </a:endParaRPr>
                        </a:p>
                      </p:txBody>
                    </p:sp>
                    <p:sp>
                      <p:nvSpPr>
                        <p:cNvPr id="105" name="テキスト ボックス 33"/>
                        <p:cNvSpPr/>
                        <p:nvPr/>
                      </p:nvSpPr>
                      <p:spPr>
                        <a:xfrm>
                          <a:off x="2063520" y="607680"/>
                          <a:ext cx="2570400" cy="520200"/>
                        </a:xfrm>
                        <a:prstGeom prst="rect">
                          <a:avLst/>
                        </a:prstGeom>
                        <a:noFill/>
                        <a:ln w="0">
                          <a:noFill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46800" bIns="46800" anchor="t">
                          <a:spAutoFit/>
                        </a:bodyPr>
                        <a:p>
                          <a:pPr>
                            <a:lnSpc>
                              <a:spcPct val="100000"/>
                            </a:lnSpc>
                            <a:tabLst>
                              <a:tab algn="l" pos="0"/>
                              <a:tab algn="l" pos="914400"/>
                              <a:tab algn="l" pos="1828800"/>
                              <a:tab algn="l" pos="2743200"/>
                              <a:tab algn="l" pos="3657600"/>
                              <a:tab algn="l" pos="4572000"/>
                              <a:tab algn="l" pos="5486400"/>
                              <a:tab algn="l" pos="6400800"/>
                              <a:tab algn="l" pos="7315200"/>
                              <a:tab algn="l" pos="8229600"/>
                              <a:tab algn="l" pos="9144000"/>
                              <a:tab algn="l" pos="10058400"/>
                            </a:tabLst>
                          </a:pPr>
                          <a:r>
                            <a:rPr b="0" lang="en-US" sz="1400" spc="-1" strike="noStrike">
                              <a:solidFill>
                                <a:srgbClr val="7030a0"/>
                              </a:solidFill>
                              <a:latin typeface="Arial"/>
                              <a:ea typeface="Arial"/>
                            </a:rPr>
                            <a:t>MSPT</a:t>
                          </a:r>
                          <a:r>
                            <a:rPr b="0" lang="ja-JP" sz="1400" spc="-1" strike="noStrike">
                              <a:solidFill>
                                <a:srgbClr val="ed7d31"/>
                              </a:solidFill>
                              <a:latin typeface="Arial"/>
                              <a:ea typeface="ＭＳ 明朝"/>
                            </a:rPr>
                            <a:t>　</a:t>
                          </a:r>
                          <a:r>
                            <a:rPr b="0" lang="en-US" sz="1400" spc="-1" strike="noStrike">
                              <a:solidFill>
                                <a:srgbClr val="000000"/>
                              </a:solidFill>
                              <a:latin typeface="Arial"/>
                              <a:ea typeface="Arial"/>
                            </a:rPr>
                            <a:t>=</a:t>
                          </a:r>
                          <a:r>
                            <a:rPr b="0" lang="en-US" sz="1400" spc="-1" strike="noStrike">
                              <a:solidFill>
                                <a:srgbClr val="ed7d31"/>
                              </a:solidFill>
                              <a:latin typeface="Arial"/>
                              <a:ea typeface="Arial"/>
                            </a:rPr>
                            <a:t> MSPQ</a:t>
                          </a:r>
                          <a:r>
                            <a:rPr b="0" lang="ja-JP" sz="1400" spc="-1" strike="noStrike">
                              <a:solidFill>
                                <a:srgbClr val="ed7d31"/>
                              </a:solidFill>
                              <a:latin typeface="Arial"/>
                              <a:ea typeface="ＭＳ 明朝"/>
                            </a:rPr>
                            <a:t> </a:t>
                          </a:r>
                          <a:r>
                            <a:rPr b="0" lang="ja-JP" sz="1400" spc="-1" strike="noStrike">
                              <a:solidFill>
                                <a:srgbClr val="000000"/>
                              </a:solidFill>
                              <a:latin typeface="Arial"/>
                              <a:ea typeface="ＭＳ 明朝"/>
                            </a:rPr>
                            <a:t>＋</a:t>
                          </a:r>
                          <a:r>
                            <a:rPr b="0" lang="en-US" sz="1400" spc="-1" strike="noStrike">
                              <a:solidFill>
                                <a:srgbClr val="ed7d31"/>
                              </a:solidFill>
                              <a:latin typeface="Arial"/>
                              <a:ea typeface="Arial"/>
                            </a:rPr>
                            <a:t> </a:t>
                          </a:r>
                          <a:r>
                            <a:rPr b="0" lang="en-US" sz="1400" spc="-1" strike="noStrike">
                              <a:solidFill>
                                <a:srgbClr val="0070c0"/>
                              </a:solidFill>
                              <a:latin typeface="Arial"/>
                              <a:ea typeface="Arial"/>
                            </a:rPr>
                            <a:t>QS</a:t>
                          </a:r>
                          <a:r>
                            <a:rPr b="0" lang="ja-JP" sz="1400" spc="-1" strike="noStrike">
                              <a:solidFill>
                                <a:srgbClr val="000000"/>
                              </a:solidFill>
                              <a:latin typeface="Arial"/>
                              <a:ea typeface="ＭＳ 明朝"/>
                            </a:rPr>
                            <a:t>－</a:t>
                          </a:r>
                          <a:r>
                            <a:rPr b="0" lang="ja-JP" sz="1400" spc="-1" strike="noStrike">
                              <a:solidFill>
                                <a:srgbClr val="0070c0"/>
                              </a:solidFill>
                              <a:latin typeface="Arial"/>
                              <a:ea typeface="ＭＳ 明朝"/>
                            </a:rPr>
                            <a:t> </a:t>
                          </a:r>
                          <a:r>
                            <a:rPr b="0" lang="en-US" sz="1400" spc="-1" strike="noStrike">
                              <a:solidFill>
                                <a:srgbClr val="00b050"/>
                              </a:solidFill>
                              <a:latin typeface="Arial"/>
                              <a:ea typeface="Arial"/>
                            </a:rPr>
                            <a:t>TS </a:t>
                          </a:r>
                          <a:endParaRPr b="0" lang="en-US" sz="1400" spc="-1" strike="noStrike">
                            <a:solidFill>
                              <a:srgbClr val="000000"/>
                            </a:solidFill>
                            <a:latin typeface="Calibri"/>
                          </a:endParaRPr>
                        </a:p>
                      </p:txBody>
                    </p:sp>
                  </p:grpSp>
                </p:grpSp>
                <p:sp>
                  <p:nvSpPr>
                    <p:cNvPr id="106" name="左大かっこ 40"/>
                    <p:cNvSpPr/>
                    <p:nvPr/>
                  </p:nvSpPr>
                  <p:spPr>
                    <a:xfrm rot="5400000">
                      <a:off x="6511320" y="-1679040"/>
                      <a:ext cx="108000" cy="6761520"/>
                    </a:xfrm>
                    <a:custGeom>
                      <a:avLst/>
                      <a:gdLst>
                        <a:gd name="textAreaLeft" fmla="*/ 31680 w 108000"/>
                        <a:gd name="textAreaRight" fmla="*/ 108360 w 108000"/>
                        <a:gd name="textAreaTop" fmla="*/ 4320 h 6761520"/>
                        <a:gd name="textAreaBottom" fmla="*/ 6757200 h 6761520"/>
                      </a:gdLst>
                      <a:ahLst/>
                      <a:rect l="textAreaLeft" t="textAreaTop" r="textAreaRight" b="textAreaBottom"/>
                      <a:pathLst>
                        <a:path w="21600" h="21600">
                          <a:moveTo>
                            <a:pt x="21600" y="0"/>
                          </a:moveTo>
                          <a:cubicBezTo>
                            <a:pt x="10800" y="0"/>
                            <a:pt x="0" y="15"/>
                            <a:pt x="0" y="29"/>
                          </a:cubicBezTo>
                          <a:lnTo>
                            <a:pt x="0" y="21571"/>
                          </a:lnTo>
                          <a:cubicBezTo>
                            <a:pt x="0" y="21586"/>
                            <a:pt x="10800" y="21600"/>
                            <a:pt x="21600" y="21600"/>
                          </a:cubicBezTo>
                        </a:path>
                      </a:pathLst>
                    </a:custGeom>
                    <a:noFill/>
                    <a:ln w="6480">
                      <a:solidFill>
                        <a:srgbClr val="4472c4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  <p:sp>
                  <p:nvSpPr>
                    <p:cNvPr id="107" name="テキスト ボックス 41"/>
                    <p:cNvSpPr/>
                    <p:nvPr/>
                  </p:nvSpPr>
                  <p:spPr>
                    <a:xfrm>
                      <a:off x="5691960" y="1355400"/>
                      <a:ext cx="380520" cy="307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46800" bIns="4680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b0f0"/>
                          </a:solidFill>
                          <a:latin typeface="Arial"/>
                          <a:ea typeface="Arial"/>
                        </a:rPr>
                        <a:t>Lt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  <p:sp>
                  <p:nvSpPr>
                    <p:cNvPr id="108" name="テキスト ボックス 51"/>
                    <p:cNvSpPr/>
                    <p:nvPr/>
                  </p:nvSpPr>
                  <p:spPr>
                    <a:xfrm>
                      <a:off x="9713160" y="1421640"/>
                      <a:ext cx="351360" cy="2764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46800" bIns="4680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7030a0"/>
                          </a:solidFill>
                          <a:latin typeface="Arial"/>
                          <a:ea typeface="Arial"/>
                        </a:rPr>
                        <a:t>5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</p:grpSp>
              <p:sp>
                <p:nvSpPr>
                  <p:cNvPr id="109" name="正方形/長方形 38"/>
                  <p:cNvSpPr/>
                  <p:nvPr/>
                </p:nvSpPr>
                <p:spPr>
                  <a:xfrm>
                    <a:off x="3541680" y="1755720"/>
                    <a:ext cx="5757840" cy="746280"/>
                  </a:xfrm>
                  <a:prstGeom prst="rect">
                    <a:avLst/>
                  </a:prstGeom>
                  <a:solidFill>
                    <a:srgbClr val="e2f0d9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10" name="テキスト ボックス 1"/>
                  <p:cNvSpPr/>
                  <p:nvPr/>
                </p:nvSpPr>
                <p:spPr>
                  <a:xfrm>
                    <a:off x="3270960" y="1688760"/>
                    <a:ext cx="6886440" cy="398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2000" spc="-1" strike="noStrike">
                        <a:solidFill>
                          <a:srgbClr val="000000"/>
                        </a:solidFill>
                        <a:latin typeface="Courier New"/>
                        <a:ea typeface="Courier New"/>
                      </a:rPr>
                      <a:t>GGCCGTCATGGCGCCCCGAACCCTCCTCCTGCTACTCTCGGGGG</a:t>
                    </a:r>
                    <a:endParaRPr b="0" lang="en-US" sz="2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11" name="テキスト ボックス 29"/>
                  <p:cNvSpPr/>
                  <p:nvPr/>
                </p:nvSpPr>
                <p:spPr>
                  <a:xfrm>
                    <a:off x="2853000" y="2224800"/>
                    <a:ext cx="6581520" cy="398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2000" spc="-1" strike="noStrike">
                        <a:solidFill>
                          <a:srgbClr val="000000"/>
                        </a:solidFill>
                        <a:latin typeface="Courier New"/>
                        <a:ea typeface="Courier New"/>
                      </a:rPr>
                      <a:t>GACCCCGTCATGGCGCCCCGAACCCTCCTCCTGCTACTCTCG</a:t>
                    </a:r>
                    <a:endParaRPr b="0" lang="en-US" sz="2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</p:grpSp>
          <p:sp>
            <p:nvSpPr>
              <p:cNvPr id="112" name="テキスト ボックス 56"/>
              <p:cNvSpPr/>
              <p:nvPr/>
            </p:nvSpPr>
            <p:spPr>
              <a:xfrm>
                <a:off x="806040" y="561960"/>
                <a:ext cx="31644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A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3" name="正方形/長方形 1"/>
              <p:cNvSpPr/>
              <p:nvPr/>
            </p:nvSpPr>
            <p:spPr>
              <a:xfrm>
                <a:off x="870480" y="1669680"/>
                <a:ext cx="192816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HLA cDNA database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4" name="正方形/長方形 2"/>
              <p:cNvSpPr/>
              <p:nvPr/>
            </p:nvSpPr>
            <p:spPr>
              <a:xfrm>
                <a:off x="552600" y="2219040"/>
                <a:ext cx="22096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Candidates of haplotype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cxnSp>
          <p:nvCxnSpPr>
            <p:cNvPr id="115" name="直線矢印コネクタ 67"/>
            <p:cNvCxnSpPr/>
            <p:nvPr/>
          </p:nvCxnSpPr>
          <p:spPr>
            <a:xfrm>
              <a:off x="3213000" y="2216160"/>
              <a:ext cx="6085440" cy="11520"/>
            </a:xfrm>
            <a:prstGeom prst="straightConnector1">
              <a:avLst/>
            </a:prstGeom>
            <a:ln w="12600">
              <a:solidFill>
                <a:srgbClr val="ff0000"/>
              </a:solidFill>
              <a:miter/>
              <a:headEnd len="med" type="arrow" w="med"/>
              <a:tailEnd len="med" type="arrow" w="med"/>
            </a:ln>
          </p:spPr>
        </p:cxnSp>
        <p:sp>
          <p:nvSpPr>
            <p:cNvPr id="116" name="正方形/長方形 1"/>
            <p:cNvSpPr/>
            <p:nvPr/>
          </p:nvSpPr>
          <p:spPr>
            <a:xfrm>
              <a:off x="2789640" y="1900440"/>
              <a:ext cx="4611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ff0000"/>
                  </a:solidFill>
                  <a:latin typeface="Arial"/>
                  <a:ea typeface="Arial"/>
                </a:rPr>
                <a:t>OL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17" name="正方形/長方形 74"/>
          <p:cNvSpPr/>
          <p:nvPr/>
        </p:nvSpPr>
        <p:spPr>
          <a:xfrm>
            <a:off x="4461840" y="4221000"/>
            <a:ext cx="418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  <a:ea typeface="Arial"/>
              </a:rPr>
              <a:t>OL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直線コネクタ 11"/>
          <p:cNvSpPr/>
          <p:nvPr/>
        </p:nvSpPr>
        <p:spPr>
          <a:xfrm>
            <a:off x="4862520" y="4494240"/>
            <a:ext cx="431640" cy="522360"/>
          </a:xfrm>
          <a:prstGeom prst="line">
            <a:avLst/>
          </a:prstGeom>
          <a:ln w="64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テキスト ボックス 1"/>
          <p:cNvSpPr/>
          <p:nvPr/>
        </p:nvSpPr>
        <p:spPr>
          <a:xfrm>
            <a:off x="163440" y="63360"/>
            <a:ext cx="12011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Figure S2.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Calculation of the OL (</a:t>
            </a:r>
            <a:r>
              <a:rPr b="0" lang="en-US" sz="1600" spc="-1" strike="noStrike" u="sng">
                <a:solidFill>
                  <a:srgbClr val="000000"/>
                </a:solidFill>
                <a:uFillTx/>
                <a:latin typeface="Arial"/>
                <a:ea typeface="Arial"/>
              </a:rPr>
              <a:t>O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verlapped </a:t>
            </a:r>
            <a:r>
              <a:rPr b="0" lang="en-US" sz="1600" spc="-1" strike="noStrike" u="sng">
                <a:solidFill>
                  <a:srgbClr val="000000"/>
                </a:solidFill>
                <a:uFillTx/>
                <a:latin typeface="Arial"/>
                <a:ea typeface="Arial"/>
              </a:rPr>
              <a:t>L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ength) between sequences of  “Candidates of haplotype” and “HLA cDNA database”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59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2-27T08:55:04Z</dcterms:created>
  <dc:creator>Segawa</dc:creator>
  <dc:description/>
  <dc:language>en-US</dc:language>
  <cp:lastModifiedBy>加藤 菊也</cp:lastModifiedBy>
  <dcterms:modified xsi:type="dcterms:W3CDTF">2017-03-28T04:41:13Z</dcterms:modified>
  <cp:revision>33</cp:revision>
  <dc:subject/>
  <dc:title>PowerPoint プレゼンテーション</dc:title>
</cp:coreProperties>
</file>